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0" userDrawn="1">
          <p15:clr>
            <a:srgbClr val="A4A3A4"/>
          </p15:clr>
        </p15:guide>
        <p15:guide id="2" pos="144" userDrawn="1">
          <p15:clr>
            <a:srgbClr val="A4A3A4"/>
          </p15:clr>
        </p15:guide>
        <p15:guide id="3" orient="horz" pos="205">
          <p15:clr>
            <a:srgbClr val="A4A3A4"/>
          </p15:clr>
        </p15:guide>
        <p15:guide id="4" pos="13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240"/>
        <p:guide pos="144"/>
        <p:guide orient="horz" pos="205"/>
        <p:guide pos="13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>
            <a:extLst>
              <a:ext uri="{FF2B5EF4-FFF2-40B4-BE49-F238E27FC236}">
                <a16:creationId xmlns:a16="http://schemas.microsoft.com/office/drawing/2014/main" id="{C5D89DF6-10F1-49FB-98D6-062F1A001DCF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238060" y="3538112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236F7BA-B188-427E-AFE5-95D0F2AD6AA2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238060" y="2496788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EF8283B7-48E3-4DEA-928D-C079CD9BA005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38060" y="1976126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51C920A4-1401-44F7-9CFE-A49356213D72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238060" y="3017450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B17C486-A0E7-4C56-9039-B2938E55010A}"/>
              </a:ext>
            </a:extLst>
          </p:cNvPr>
          <p:cNvCxnSpPr/>
          <p:nvPr/>
        </p:nvCxnSpPr>
        <p:spPr>
          <a:xfrm>
            <a:off x="1312641" y="4080440"/>
            <a:ext cx="131387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B5D541BA-3770-4C34-B3FF-65E058E0C74B}"/>
              </a:ext>
            </a:extLst>
          </p:cNvPr>
          <p:cNvSpPr txBox="1"/>
          <p:nvPr/>
        </p:nvSpPr>
        <p:spPr>
          <a:xfrm>
            <a:off x="2708535" y="2028378"/>
            <a:ext cx="10567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ErbB4 (1284)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B7B5EEF-06D5-4B3E-996A-D2A52344209F}"/>
              </a:ext>
            </a:extLst>
          </p:cNvPr>
          <p:cNvSpPr txBox="1"/>
          <p:nvPr/>
        </p:nvSpPr>
        <p:spPr>
          <a:xfrm>
            <a:off x="2708533" y="2536865"/>
            <a:ext cx="10567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ErbB3 (1289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28A1FFD-CF9A-475C-A3FB-356CF0A02C34}"/>
              </a:ext>
            </a:extLst>
          </p:cNvPr>
          <p:cNvSpPr txBox="1"/>
          <p:nvPr/>
        </p:nvSpPr>
        <p:spPr>
          <a:xfrm>
            <a:off x="2708533" y="3060864"/>
            <a:ext cx="10567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ErbB2 (1248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3C3C8E1-AE03-4FB2-8A6A-08B20C3D3F05}"/>
              </a:ext>
            </a:extLst>
          </p:cNvPr>
          <p:cNvSpPr txBox="1"/>
          <p:nvPr/>
        </p:nvSpPr>
        <p:spPr>
          <a:xfrm>
            <a:off x="2916923" y="3601646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8174B5D-DE12-412B-871C-B839A717BEAA}"/>
              </a:ext>
            </a:extLst>
          </p:cNvPr>
          <p:cNvSpPr txBox="1"/>
          <p:nvPr/>
        </p:nvSpPr>
        <p:spPr>
          <a:xfrm>
            <a:off x="1706968" y="4117232"/>
            <a:ext cx="6319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CR2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FF1889A-1334-49D8-B362-3FFE124C9888}"/>
              </a:ext>
            </a:extLst>
          </p:cNvPr>
          <p:cNvSpPr txBox="1"/>
          <p:nvPr/>
        </p:nvSpPr>
        <p:spPr>
          <a:xfrm rot="16200000">
            <a:off x="1502156" y="1203843"/>
            <a:ext cx="965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-099 (6h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681666C-4F03-4CDB-8C5B-E3CBCCAD4F3E}"/>
              </a:ext>
            </a:extLst>
          </p:cNvPr>
          <p:cNvSpPr txBox="1"/>
          <p:nvPr/>
        </p:nvSpPr>
        <p:spPr>
          <a:xfrm rot="16200000">
            <a:off x="1994838" y="1168577"/>
            <a:ext cx="10358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-099 (24h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03F35E0-A195-4919-BAD3-311FBB43CDDE}"/>
              </a:ext>
            </a:extLst>
          </p:cNvPr>
          <p:cNvSpPr txBox="1"/>
          <p:nvPr/>
        </p:nvSpPr>
        <p:spPr>
          <a:xfrm rot="16200000">
            <a:off x="1255184" y="1416241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 Rx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727C17D9-C5EA-4A1D-B754-85B7C9482BC5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817621" y="3538112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133BC060-526B-4435-A7F7-81130E479670}"/>
              </a:ext>
            </a:extLst>
          </p:cNvPr>
          <p:cNvCxnSpPr/>
          <p:nvPr/>
        </p:nvCxnSpPr>
        <p:spPr>
          <a:xfrm>
            <a:off x="3930302" y="4080440"/>
            <a:ext cx="131387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C1348C53-142E-4C7D-AE2B-F0208BDD6635}"/>
              </a:ext>
            </a:extLst>
          </p:cNvPr>
          <p:cNvSpPr txBox="1"/>
          <p:nvPr/>
        </p:nvSpPr>
        <p:spPr>
          <a:xfrm>
            <a:off x="4280535" y="4115686"/>
            <a:ext cx="689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6B534D9-DFDB-44DF-9EA6-E7644FFBEA92}"/>
              </a:ext>
            </a:extLst>
          </p:cNvPr>
          <p:cNvSpPr txBox="1"/>
          <p:nvPr/>
        </p:nvSpPr>
        <p:spPr>
          <a:xfrm rot="16200000">
            <a:off x="4065590" y="1203843"/>
            <a:ext cx="965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-099 (6h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D63D8D98-9A23-47C8-BB2A-D43886E6FB8B}"/>
              </a:ext>
            </a:extLst>
          </p:cNvPr>
          <p:cNvSpPr txBox="1"/>
          <p:nvPr/>
        </p:nvSpPr>
        <p:spPr>
          <a:xfrm rot="16200000">
            <a:off x="4527792" y="1168577"/>
            <a:ext cx="1035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-099 (24h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D8C3355-8C5A-400C-9B3E-A441F07C8507}"/>
              </a:ext>
            </a:extLst>
          </p:cNvPr>
          <p:cNvSpPr txBox="1"/>
          <p:nvPr/>
        </p:nvSpPr>
        <p:spPr>
          <a:xfrm rot="16200000">
            <a:off x="3818618" y="1416241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 Rx</a:t>
            </a: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57DEB42D-F307-4BF8-A8E5-62F04822451A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817621" y="3017450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4A578772-5D53-4F64-AAF4-2BA1FF4561B6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817620" y="2495723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5A2C779F-58D8-4D16-904D-BE7D55E68C01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817620" y="1976126"/>
            <a:ext cx="1490472" cy="283464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ACA716F-C3B5-B9E4-B8C7-7EB1E4131D41}"/>
              </a:ext>
            </a:extLst>
          </p:cNvPr>
          <p:cNvSpPr txBox="1"/>
          <p:nvPr/>
        </p:nvSpPr>
        <p:spPr>
          <a:xfrm>
            <a:off x="142086" y="4690464"/>
            <a:ext cx="65444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5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analysis of ErbB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mbers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ICR22 and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HU-022 cells were treated with or without 10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P099 for 24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r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extracted proteins were subjected to western blot analyses with the indicated antibodies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656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1</TotalTime>
  <Words>74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64</cp:revision>
  <cp:lastPrinted>2019-09-23T20:12:05Z</cp:lastPrinted>
  <dcterms:created xsi:type="dcterms:W3CDTF">2019-03-07T03:13:48Z</dcterms:created>
  <dcterms:modified xsi:type="dcterms:W3CDTF">2022-07-07T10:40:57Z</dcterms:modified>
</cp:coreProperties>
</file>